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99A27C-49E5-467B-8822-ED0821A47A1F}" type="datetimeFigureOut">
              <a:rPr lang="zh-CN" altLang="en-US" smtClean="0"/>
              <a:t>2019/5/3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54FAFE-2A1B-46B2-9F7D-503CB422D5F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437994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99A27C-49E5-467B-8822-ED0821A47A1F}" type="datetimeFigureOut">
              <a:rPr lang="zh-CN" altLang="en-US" smtClean="0"/>
              <a:t>2019/5/3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54FAFE-2A1B-46B2-9F7D-503CB422D5F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205277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99A27C-49E5-467B-8822-ED0821A47A1F}" type="datetimeFigureOut">
              <a:rPr lang="zh-CN" altLang="en-US" smtClean="0"/>
              <a:t>2019/5/3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54FAFE-2A1B-46B2-9F7D-503CB422D5F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200298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99A27C-49E5-467B-8822-ED0821A47A1F}" type="datetimeFigureOut">
              <a:rPr lang="zh-CN" altLang="en-US" smtClean="0"/>
              <a:t>2019/5/3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54FAFE-2A1B-46B2-9F7D-503CB422D5F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052621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99A27C-49E5-467B-8822-ED0821A47A1F}" type="datetimeFigureOut">
              <a:rPr lang="zh-CN" altLang="en-US" smtClean="0"/>
              <a:t>2019/5/3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54FAFE-2A1B-46B2-9F7D-503CB422D5F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174205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99A27C-49E5-467B-8822-ED0821A47A1F}" type="datetimeFigureOut">
              <a:rPr lang="zh-CN" altLang="en-US" smtClean="0"/>
              <a:t>2019/5/3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54FAFE-2A1B-46B2-9F7D-503CB422D5F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176732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99A27C-49E5-467B-8822-ED0821A47A1F}" type="datetimeFigureOut">
              <a:rPr lang="zh-CN" altLang="en-US" smtClean="0"/>
              <a:t>2019/5/3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54FAFE-2A1B-46B2-9F7D-503CB422D5F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625040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99A27C-49E5-467B-8822-ED0821A47A1F}" type="datetimeFigureOut">
              <a:rPr lang="zh-CN" altLang="en-US" smtClean="0"/>
              <a:t>2019/5/3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54FAFE-2A1B-46B2-9F7D-503CB422D5F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277402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99A27C-49E5-467B-8822-ED0821A47A1F}" type="datetimeFigureOut">
              <a:rPr lang="zh-CN" altLang="en-US" smtClean="0"/>
              <a:t>2019/5/3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54FAFE-2A1B-46B2-9F7D-503CB422D5F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853617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99A27C-49E5-467B-8822-ED0821A47A1F}" type="datetimeFigureOut">
              <a:rPr lang="zh-CN" altLang="en-US" smtClean="0"/>
              <a:t>2019/5/3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54FAFE-2A1B-46B2-9F7D-503CB422D5F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630023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99A27C-49E5-467B-8822-ED0821A47A1F}" type="datetimeFigureOut">
              <a:rPr lang="zh-CN" altLang="en-US" smtClean="0"/>
              <a:t>2019/5/3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54FAFE-2A1B-46B2-9F7D-503CB422D5F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886472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99A27C-49E5-467B-8822-ED0821A47A1F}" type="datetimeFigureOut">
              <a:rPr lang="zh-CN" altLang="en-US" smtClean="0"/>
              <a:t>2019/5/3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54FAFE-2A1B-46B2-9F7D-503CB422D5F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674220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1920097" y="5062718"/>
            <a:ext cx="8347575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4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qRT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-PCR analysis of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CER1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 expression in wild-type Col-0 (WT) plants, Arabidopsis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r1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utant and transgenic lines. The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ACT8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 was used as a constitutively expressed control. Results are presented as relative expression levels. The date represents the means ± standard deviations of three technical replicates.</a:t>
            </a:r>
            <a:endParaRPr lang="zh-CN" altLang="zh-C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zh-CN" altLang="zh-C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59736" y="173159"/>
            <a:ext cx="6662928" cy="474878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814345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8</Words>
  <Application>Microsoft Office PowerPoint</Application>
  <PresentationFormat>宽屏</PresentationFormat>
  <Paragraphs>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宋体</vt:lpstr>
      <vt:lpstr>Arial</vt:lpstr>
      <vt:lpstr>Calibri</vt:lpstr>
      <vt:lpstr>Calibri Light</vt:lpstr>
      <vt:lpstr>Times New Roman</vt:lpstr>
      <vt:lpstr>Office 主题</vt:lpstr>
      <vt:lpstr>PowerPoint 演示文稿</vt:lpstr>
    </vt:vector>
  </TitlesOfParts>
  <Company>P R C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indows User</dc:creator>
  <cp:lastModifiedBy>Windows User</cp:lastModifiedBy>
  <cp:revision>3</cp:revision>
  <dcterms:created xsi:type="dcterms:W3CDTF">2019-02-22T04:15:11Z</dcterms:created>
  <dcterms:modified xsi:type="dcterms:W3CDTF">2019-05-31T02:34:00Z</dcterms:modified>
</cp:coreProperties>
</file>